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embeddings/oleObject1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D1173C-2F05-4429-AA83-F9331B565BB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589F95-01E3-4676-9CB1-02CDF26915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78B060-5510-4F93-913B-8137DE93D8D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25B867-1ED3-4728-A205-111DB9FD132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A5275B-F1B8-49DE-BB35-CED04357FE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248B93-34D1-4830-B23F-04634397B1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E4219E-CF0B-46C8-879B-9759D6CC7D5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5253A1-8C88-4A81-89A6-08C6FA65E20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1B45FD-6491-4BF3-97E8-EBF8DC33456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CFBC56-328C-440F-A23F-C9352782DB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1FEEBB-D001-458F-9535-E83160E167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0E49B5-78B6-4128-A8E5-90F0404AA9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5A041FB-BA98-48EC-94C2-AA767D292E6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oleObject" Target="../embeddings/oleObject1.bin"/><Relationship Id="rId3" Type="http://schemas.openxmlformats.org/officeDocument/2006/relationships/image" Target="../media/image2.pn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5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1584000" y="485640"/>
            <a:ext cx="8529480" cy="7668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1.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i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Rhizobium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sp.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IRBG74 can colonize </a:t>
            </a:r>
            <a:r>
              <a:rPr b="0" i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rabidopsis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Root.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olumbia (Col-0) 4-day seedlings without (A) and with (B) </a:t>
            </a:r>
            <a:r>
              <a:rPr b="0" i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Rhizobium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sp. IRBG74-GUS treatment for 2 days.</a:t>
            </a:r>
            <a:endParaRPr b="0" lang="en-US" sz="1600" spc="-1" strike="noStrike">
              <a:solidFill>
                <a:srgbClr val="000000"/>
              </a:solidFill>
              <a:latin typeface="Calibri Light"/>
            </a:endParaRPr>
          </a:p>
        </p:txBody>
      </p:sp>
      <p:grpSp>
        <p:nvGrpSpPr>
          <p:cNvPr id="42" name="Group 5"/>
          <p:cNvGrpSpPr/>
          <p:nvPr/>
        </p:nvGrpSpPr>
        <p:grpSpPr>
          <a:xfrm>
            <a:off x="1908000" y="1587600"/>
            <a:ext cx="8142480" cy="3875040"/>
            <a:chOff x="1908000" y="1587600"/>
            <a:chExt cx="8142480" cy="3875040"/>
          </a:xfrm>
        </p:grpSpPr>
        <p:pic>
          <p:nvPicPr>
            <p:cNvPr id="43" name="Picture 3" descr=""/>
            <p:cNvPicPr/>
            <p:nvPr/>
          </p:nvPicPr>
          <p:blipFill>
            <a:blip r:embed="rId1"/>
            <a:stretch/>
          </p:blipFill>
          <p:spPr>
            <a:xfrm>
              <a:off x="3204720" y="2047680"/>
              <a:ext cx="6845760" cy="3414960"/>
            </a:xfrm>
            <a:prstGeom prst="rect">
              <a:avLst/>
            </a:prstGeom>
            <a:ln w="0">
              <a:noFill/>
            </a:ln>
          </p:spPr>
        </p:pic>
        <p:graphicFrame>
          <p:nvGraphicFramePr>
            <p:cNvPr id="44" name="Object 4"/>
            <p:cNvGraphicFramePr/>
            <p:nvPr/>
          </p:nvGraphicFramePr>
          <p:xfrm>
            <a:off x="1908000" y="2047680"/>
            <a:ext cx="1046160" cy="3414960"/>
          </p:xfrm>
          <a:graphic>
            <a:graphicData uri="http://schemas.openxmlformats.org/presentationml/2006/ole">
              <p:oleObj r:id="rId2" spid="">
                <p:embed/>
                <p:pic>
                  <p:nvPicPr>
                    <p:cNvPr id="45" name="Object 4" descr=""/>
                    <p:cNvPicPr/>
                    <p:nvPr/>
                  </p:nvPicPr>
                  <p:blipFill>
                    <a:blip r:embed="rId3"/>
                    <a:stretch/>
                  </p:blipFill>
                  <p:spPr>
                    <a:xfrm>
                      <a:off x="1908000" y="2047680"/>
                      <a:ext cx="1046160" cy="34149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6" name="TextBox 2"/>
            <p:cNvSpPr/>
            <p:nvPr/>
          </p:nvSpPr>
          <p:spPr>
            <a:xfrm>
              <a:off x="2249280" y="1587600"/>
              <a:ext cx="52128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800" spc="-1" strike="noStrike">
                  <a:solidFill>
                    <a:srgbClr val="000000"/>
                  </a:solidFill>
                  <a:latin typeface="Arial"/>
                  <a:ea typeface="Arial"/>
                </a:rPr>
                <a:t>A</a:t>
              </a:r>
              <a:endParaRPr b="0" lang="en-US" sz="2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TextBox 6"/>
            <p:cNvSpPr/>
            <p:nvPr/>
          </p:nvSpPr>
          <p:spPr>
            <a:xfrm>
              <a:off x="6566760" y="1587600"/>
              <a:ext cx="52128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800" spc="-1" strike="noStrike">
                  <a:solidFill>
                    <a:srgbClr val="000000"/>
                  </a:solidFill>
                  <a:latin typeface="Arial"/>
                  <a:ea typeface="Arial"/>
                </a:rPr>
                <a:t>B</a:t>
              </a:r>
              <a:endParaRPr b="0" lang="en-US" sz="2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1584000" y="485640"/>
            <a:ext cx="8529480" cy="7668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2.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Gene ontological annotation by cellular component.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Differentially expressed genes at 24 and 48 hours were functionally categorized from TAIR.</a:t>
            </a:r>
            <a:endParaRPr b="0" lang="en-US" sz="1600" spc="-1" strike="noStrike">
              <a:solidFill>
                <a:srgbClr val="000000"/>
              </a:solidFill>
              <a:latin typeface="Calibri Light"/>
            </a:endParaRPr>
          </a:p>
        </p:txBody>
      </p:sp>
      <p:graphicFrame>
        <p:nvGraphicFramePr>
          <p:cNvPr id="49" name="Object 3"/>
          <p:cNvGraphicFramePr/>
          <p:nvPr/>
        </p:nvGraphicFramePr>
        <p:xfrm>
          <a:off x="1684440" y="1395360"/>
          <a:ext cx="8109000" cy="44290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0" name="Object 3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684440" y="1395360"/>
                    <a:ext cx="8109000" cy="4429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1525680" y="469800"/>
            <a:ext cx="8531280" cy="7653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3.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Gene ontological annotation by molecular function.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Differentially expressed genes at 24 and 48 hours were functionally categorized from TAIR.</a:t>
            </a:r>
            <a:endParaRPr b="0" lang="en-US" sz="1600" spc="-1" strike="noStrike">
              <a:solidFill>
                <a:srgbClr val="000000"/>
              </a:solidFill>
              <a:latin typeface="Calibri Light"/>
            </a:endParaRPr>
          </a:p>
        </p:txBody>
      </p:sp>
      <p:graphicFrame>
        <p:nvGraphicFramePr>
          <p:cNvPr id="52" name="Object 3"/>
          <p:cNvGraphicFramePr/>
          <p:nvPr/>
        </p:nvGraphicFramePr>
        <p:xfrm>
          <a:off x="1666800" y="1366920"/>
          <a:ext cx="8109000" cy="44244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3" name="Object 3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666800" y="1366920"/>
                    <a:ext cx="8109000" cy="4424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title"/>
          </p:nvPr>
        </p:nvSpPr>
        <p:spPr>
          <a:xfrm>
            <a:off x="1262160" y="518760"/>
            <a:ext cx="8531280" cy="765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4.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Gene ontological annotation by biological process.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Differentially expressed genes at 24 and 48 hours were functionally categorized from TAIR.</a:t>
            </a:r>
            <a:endParaRPr b="0" lang="en-US" sz="1600" spc="-1" strike="noStrike">
              <a:solidFill>
                <a:srgbClr val="000000"/>
              </a:solidFill>
              <a:latin typeface="Calibri Light"/>
            </a:endParaRPr>
          </a:p>
        </p:txBody>
      </p:sp>
      <p:graphicFrame>
        <p:nvGraphicFramePr>
          <p:cNvPr id="55" name="Object 3"/>
          <p:cNvGraphicFramePr/>
          <p:nvPr/>
        </p:nvGraphicFramePr>
        <p:xfrm>
          <a:off x="1347840" y="1405080"/>
          <a:ext cx="8636040" cy="39654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6" name="Object 3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347840" y="1405080"/>
                    <a:ext cx="8636040" cy="3965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9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3-21T02:43:52Z</dcterms:created>
  <dc:creator>Dazhong Zhao</dc:creator>
  <dc:description/>
  <dc:language>en-US</dc:language>
  <cp:lastModifiedBy>Dazhong Zhao</cp:lastModifiedBy>
  <dcterms:modified xsi:type="dcterms:W3CDTF">2017-12-08T05:39:49Z</dcterms:modified>
  <cp:revision>21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1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TitleName">
    <vt:lpwstr>Presentation 1.PPT</vt:lpwstr>
  </property>
</Properties>
</file>